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_rels/presentation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3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</p:sldMasterIdLst>
  <p:sldIdLst>
    <p:sldId id="256" r:id="rId14"/>
    <p:sldId id="257" r:id="rId15"/>
    <p:sldId id="258" r:id="rId1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" Target="slides/slide1.xml"/><Relationship Id="rId15" Type="http://schemas.openxmlformats.org/officeDocument/2006/relationships/slide" Target="slides/slide2.xml"/><Relationship Id="rId16" Type="http://schemas.openxmlformats.org/officeDocument/2006/relationships/slide" Target="slides/slide3.xml"/><Relationship Id="rId1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FA32C4-1A32-4DDB-8B68-8BF231CE78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BD9345-AC5A-480D-84DE-2CC6E84547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75CABB32-E425-417C-92C6-F2B589A780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712A867C-1DA2-482C-9DD4-FDCEED2E96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5728CD82-949E-4EC1-A138-E25A251CB4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C411379-AC19-4C82-8D37-4EBBADEA1F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49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AAE6749-2DED-4D7B-9CDE-402C88D63C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E56F452C-5A12-48B4-A466-356F40F07F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6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B703EED-3925-400F-A5DE-1DC47AA99B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1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BB5677D4-73DB-40EA-A63B-CB44B810984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4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5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6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7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8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59B17055-0F02-4462-9445-0AA6F5E996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08292123-BF84-46AD-A899-BE0D9BFFF79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18B9DD-27C6-4B32-AAF0-2AEE051A39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5EB11140-5683-44AC-B592-D65FAC485C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EF0DB2E4-DCC2-49A0-B0DA-43680EE16B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3283BC6-C992-4A17-ABB0-DB587D2FFD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3C0D65A5-8FF9-4956-AA42-13A754CC19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E668E277-5F78-4C10-896D-E46376DF90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E9EB8FA-3FB6-4F91-B033-59E3539B21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EA71421B-B6FE-4E9A-BB0F-1C9031C3A9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165CE43A-3856-41D8-8E78-68E9BC4319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E2B5791F-B0B5-47AC-A475-C8F9B41C67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CE0BC43-5167-4B7B-A333-13DDCFE49B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263333-AE1E-4C87-83D3-58C05A34923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255F28A-5712-46CB-B4BE-51D28F7655A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F134984-BE1D-4755-9746-28DFDA0B149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B3721488-B2EF-4BFC-8226-676653745C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8262F96-D7E2-4F3E-81BF-08E0189973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C6C4E1F9-F108-45FE-A5F3-FF92E1A262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9DD694D-CC8A-4AF5-84CA-3BF1DA4E4C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AD369274-CF85-4720-80E9-AEC8836821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2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2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2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212E1282-D24C-4E47-B214-1178C66CA2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65E06406-771B-4E4B-9D9C-A9DFA40F3C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3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9646FB4-CA2D-472A-85B1-8158AAA0AD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D11346D-D420-4064-875D-C5DB910DC3C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3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3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4CA6F967-F93F-42BF-84F9-2D946763A9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68EED70E-39F6-4465-899A-73C88C90E93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5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3DCCD5D6-F465-4A75-89E2-70FEED3A3DD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0A1201F5-D894-4BD0-85AB-FBA2E17C90D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5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9C56C001-D7A1-463E-B310-52FCFE4F5B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5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C7A3A274-9F5A-4DE4-838D-030A012E38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E390F5FB-A585-4E3C-BFF2-472D98B554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2F56C85E-390E-46E2-ACD5-904C88E80D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ADAE3134-3118-40CE-841A-8FDEB78E63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80E2E474-151E-4DA1-A59D-1F434805D6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8409E08-2F65-47C9-8E7E-06F80E4F7F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7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7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8C21DDF8-1EE8-43EE-AED8-2FAD4AC577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7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7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EFE9A082-DFED-45AC-AC43-37A3D7764B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EC4589BA-FCDC-4A59-A375-E281192CD2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775E35C8-A2C5-410F-9E83-5865318447F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8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9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9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F5999201-4EB7-4EE9-8563-FAE48E4DEE2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18C4203-3809-4A93-867E-264DFBD709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CF154AC-8231-4E62-B6F1-8AB7B1ACF2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3BD9D84-F871-4FF1-99CE-7EC5A9A856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CF5E89D-ABF8-43B3-92A1-213C2B8611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3A743EB-55E4-42C6-85D9-A5E021B92B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F460F9-D1AB-4ED4-834B-CFE9E93A1F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5A8FDC9-D86F-4551-BDAE-51F50EC653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C783E26-15E3-4E7A-B89C-723D68F9B8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C033F94-17D6-4031-BC12-E6AF7162D2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932BF79-44D2-4F46-87AE-5B1C796380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D5835A8-6D8E-4E35-B1B1-2AC7E22DE09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28AB0C6-D34F-41FB-8900-FE84DC315F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D88B013-F53C-4111-9FC6-92CFFC0719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4502C02-BE72-489A-8CED-199B22FF2E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94B3EC3-CC4E-48F5-A469-E16A688081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0B693F2-CB63-456B-BB14-5A2BA3AB60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DECBBF-F8F0-496A-8D08-987BEC17ED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BA186C9-2F5F-40D3-B40F-B01C522D65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3572AD7-DA56-4613-8C3E-483C1DD304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0489BF2-FCA5-491D-9009-87A5055761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AEFC297-6D56-4F6E-A0CB-07F8017D1D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1221779-AFDB-4E82-9903-53A2FE1388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E97FBC6-DCF9-447B-A64A-F2F430ED91A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B9B95E0-D662-4030-A029-39B0DCC9CB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E83710C-2D2D-472E-A4CB-00B1232B13D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A7D9ADF-C570-47A8-948A-C037DEF7B9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D354750-EB60-44A6-919D-0FF0D798C9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8AA3C6-2D05-4877-B05D-672795C44D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608507E-D41B-486F-810E-68F2985E72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01E4613-4A4A-4D93-99DF-4AA04EB8B2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1C73F0E-736F-4D2D-87EE-328A7DEFD8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D63FB37-0B73-4237-B7C1-780B0A6AC6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EBDBFDD-E019-4E09-B676-30237046E3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3EEF2AA5-841A-497D-B575-ECDDA0231E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6287039-6092-49BE-957D-366C490513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4BDE8D6-8E7D-4B78-AFE3-180B103B504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4977B00-C2B4-4948-AF2C-417651BE5DD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0D2746E-A05B-4142-AD27-E4E9623E638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9EA3DB-2772-42C0-99BE-72F7CD36CE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962E67E0-6893-4F98-8213-C03A2FF9C3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6E35D28-25BB-4686-B6E4-FF7D6FEB31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2641C2B-2893-491F-9C6C-F172AE25DB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9011D197-41CA-4A80-A7AC-C930A97B01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3AB24AEE-39AC-448E-8828-283AB2198A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E283AB0-21D7-4719-A1C6-C728FCCCE8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D1627FD3-60CB-437F-B52C-29F1EEFF20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AAFB564-009A-4625-8F46-2E37B8372A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D60A559-5E33-4F3B-9291-C89AF1A900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27A2A01-B42E-4C61-9644-9D7E989CCE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D5632A-D45B-48E8-872B-C391A11D01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1D66FEF-C371-4278-9545-3B020E18E7D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D88E60A-AEF2-4A82-BEE9-E53B253F502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A42620C-379B-4B0A-B6E2-94FD9B5852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D9C7D98-5B03-4091-8AAE-F9C514742A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D2A9C11-C6C0-4F6D-B97A-42F66961FF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0C70BA37-1B28-4197-84CB-00DAEAF652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08FE02E-81CE-43C0-A15F-D168EFB8CF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2B61F6A-4922-4796-95C1-B251B06E1A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0C41B596-1A92-41BD-AC4F-7712B8D233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0097EF8D-87CF-49DE-BC9B-0695ED4A30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7CB8F9-1407-4B0D-9FDF-60178DFA30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E409C8F7-12BE-420E-9E2C-9CD971DDD3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74C11C0-FD33-4C7C-8D97-87A836278C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1E0C542-A153-4FE8-ADD9-41FA023F85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C7AFE527-529F-465B-89E8-C8257961292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E30E3EAB-B4D2-46AF-B20D-3B002A857F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C91DD448-C81A-46CF-90F9-5F1960F529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4AFDDFC7-BF7E-4516-8B40-6759AF924A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EB181524-A9E8-4D99-A069-4205EB368A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51D190BF-D396-4181-85B3-9B53543451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BFFFB33-DC3F-4854-B1A6-24C98C514F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D4BA11-B069-4C34-A3A4-BD4FC18E23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67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744C5B80-D95A-4E3F-A0AE-E0F2F7FA32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C1AA18C2-1BA8-456A-9E5A-C1EE2A989D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FA4E5B4-1241-4011-A762-4C55CBB7AF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9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DEFFA7E7-C737-4CAD-AF15-8AB8C4C52B4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4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5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6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CE1A9D5E-7D93-40DE-9E65-ADA294168E6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D7F0FF0-2EAB-45A5-8F4C-FABF96A1AE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9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3537013D-3280-4892-8225-50E3EFC2BD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97CF4C49-DFE2-4163-ACC0-45DAD824DF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2EA07C1F-AC7A-4C2A-A314-B333DBE08B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DBBE80F-92E6-43EF-A1C8-75BC514D9D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00C115-4F5C-4C77-AF17-1C55719A25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20DCC276-6036-47A2-9FB7-9CDB7FBB68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C5D5DCE-EDA8-419D-81A8-36B5D4EBE3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B0343FA0-1494-4B95-BC21-9CFA55D3F9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D15BC8A9-3A4B-4A06-8AB6-48E8D47C44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AD48586E-1369-4FD3-89C5-53F4E0AC9D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9FF300C5-F9B8-4517-AE30-846EA0AA199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B44310ED-6E7A-45E6-92F2-AA1ECDC5FE3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7BE1136A-24EB-4902-A471-C55411EB14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4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796EEDF6-D899-40AB-BE8C-82DB9B3328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68BEA553-E00E-401B-B729-6AE663F091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73AC42-699D-4EAD-991C-495890FB1C85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 type="dt" idx="28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 type="ftr" idx="29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3" name="PlaceHolder 5"/>
          <p:cNvSpPr>
            <a:spLocks noGrp="1"/>
          </p:cNvSpPr>
          <p:nvPr>
            <p:ph type="sldNum" idx="30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B76684-5044-4590-9F7A-CAF8464335E3}" type="slidenum"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1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12" name="PlaceHolder 3"/>
          <p:cNvSpPr>
            <a:spLocks noGrp="1"/>
          </p:cNvSpPr>
          <p:nvPr>
            <p:ph type="dt" idx="3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3" name="PlaceHolder 4"/>
          <p:cNvSpPr>
            <a:spLocks noGrp="1"/>
          </p:cNvSpPr>
          <p:nvPr>
            <p:ph type="ftr" idx="3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14" name="PlaceHolder 5"/>
          <p:cNvSpPr>
            <a:spLocks noGrp="1"/>
          </p:cNvSpPr>
          <p:nvPr>
            <p:ph type="sldNum" idx="3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33B26BA-888F-4833-BCEF-FBA231436684}" type="slidenum"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 type="dt" idx="34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 type="ftr" idx="35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55" name="PlaceHolder 5"/>
          <p:cNvSpPr>
            <a:spLocks noGrp="1"/>
          </p:cNvSpPr>
          <p:nvPr>
            <p:ph type="sldNum" idx="36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54393D-F09C-4FD9-8EC7-C5CB38B1D7D7}" type="slidenum"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B2D8BE-E1D7-4BC7-9556-90E5CB691F96}" type="slidenum"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1CDDC7-7EB1-42A2-9A5F-FB097FCDA858}" type="slidenum"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44AD3D-E949-4B14-847A-CC79D01C44BC}" type="slidenum"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B77A1A-DD39-4905-ADC9-D877A13681AB}" type="slidenum"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 type="dt" idx="16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 type="ftr" idx="17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9" name="PlaceHolder 5"/>
          <p:cNvSpPr>
            <a:spLocks noGrp="1"/>
          </p:cNvSpPr>
          <p:nvPr>
            <p:ph type="sldNum" idx="18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DB8A6A-7D3A-4F65-BD3D-58F9CC354773}" type="slidenum"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 type="dt" idx="19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 type="ftr" idx="20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0" name="PlaceHolder 5"/>
          <p:cNvSpPr>
            <a:spLocks noGrp="1"/>
          </p:cNvSpPr>
          <p:nvPr>
            <p:ph type="sldNum" idx="21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CC4ABD-8438-4C44-AB83-94B62ECD458A}" type="slidenum"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 type="dt" idx="22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 type="ftr" idx="23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 type="sldNum" idx="24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A78BDA-B302-4A76-94E3-7BD21047EC2B}" type="slidenum"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0" name="PlaceHolder 3"/>
          <p:cNvSpPr>
            <a:spLocks noGrp="1"/>
          </p:cNvSpPr>
          <p:nvPr>
            <p:ph type="dt" idx="25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1" name="PlaceHolder 4"/>
          <p:cNvSpPr>
            <a:spLocks noGrp="1"/>
          </p:cNvSpPr>
          <p:nvPr>
            <p:ph type="ftr" idx="26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2" name="PlaceHolder 5"/>
          <p:cNvSpPr>
            <a:spLocks noGrp="1"/>
          </p:cNvSpPr>
          <p:nvPr>
            <p:ph type="sldNum" idx="27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FEB5544-E5A1-4921-A6C5-DF7CC52A8516}" type="slidenum">
              <a:rPr b="0" lang="ko-KR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85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8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8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2" name="그룹 23"/>
          <p:cNvGrpSpPr/>
          <p:nvPr/>
        </p:nvGrpSpPr>
        <p:grpSpPr>
          <a:xfrm>
            <a:off x="367920" y="658800"/>
            <a:ext cx="8879400" cy="4575240"/>
            <a:chOff x="367920" y="658800"/>
            <a:chExt cx="8879400" cy="4575240"/>
          </a:xfrm>
        </p:grpSpPr>
        <p:pic>
          <p:nvPicPr>
            <p:cNvPr id="493" name="그림 2" descr=""/>
            <p:cNvPicPr/>
            <p:nvPr/>
          </p:nvPicPr>
          <p:blipFill>
            <a:blip r:embed="rId1"/>
            <a:stretch/>
          </p:blipFill>
          <p:spPr>
            <a:xfrm>
              <a:off x="1118880" y="1326960"/>
              <a:ext cx="3460680" cy="3907080"/>
            </a:xfrm>
            <a:prstGeom prst="rect">
              <a:avLst/>
            </a:prstGeom>
            <a:ln w="9360">
              <a:solidFill>
                <a:srgbClr val="7f7f7f"/>
              </a:solidFill>
              <a:miter/>
            </a:ln>
          </p:spPr>
        </p:pic>
        <p:pic>
          <p:nvPicPr>
            <p:cNvPr id="494" name="그림 4" descr=""/>
            <p:cNvPicPr/>
            <p:nvPr/>
          </p:nvPicPr>
          <p:blipFill>
            <a:blip r:embed="rId2"/>
            <a:stretch/>
          </p:blipFill>
          <p:spPr>
            <a:xfrm>
              <a:off x="5503320" y="1314000"/>
              <a:ext cx="3461760" cy="3907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5" name="TextBox 10"/>
            <p:cNvSpPr/>
            <p:nvPr/>
          </p:nvSpPr>
          <p:spPr>
            <a:xfrm>
              <a:off x="979200" y="1001520"/>
              <a:ext cx="3888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DM-Hi  DM-Lo  DM-No Sham-Hi  Sham-Lo Sham-No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96" name="TextBox 8"/>
            <p:cNvSpPr/>
            <p:nvPr/>
          </p:nvSpPr>
          <p:spPr>
            <a:xfrm>
              <a:off x="971280" y="658800"/>
              <a:ext cx="3456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Western blot (Front paw) - MIF 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97" name="TextBox 10"/>
            <p:cNvSpPr/>
            <p:nvPr/>
          </p:nvSpPr>
          <p:spPr>
            <a:xfrm>
              <a:off x="5359320" y="1001520"/>
              <a:ext cx="3888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DM-Hi  DM-Lo  DM-No Sham-Hi  Sham-Lo Sham-No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98" name="TextBox 8"/>
            <p:cNvSpPr/>
            <p:nvPr/>
          </p:nvSpPr>
          <p:spPr>
            <a:xfrm>
              <a:off x="5436000" y="658800"/>
              <a:ext cx="3456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Western blot (Front paw) - CGRP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99" name="TextBox 44"/>
            <p:cNvSpPr/>
            <p:nvPr/>
          </p:nvSpPr>
          <p:spPr>
            <a:xfrm>
              <a:off x="367920" y="4518720"/>
              <a:ext cx="721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3 kDa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00" name="직사각형 20"/>
            <p:cNvSpPr/>
            <p:nvPr/>
          </p:nvSpPr>
          <p:spPr>
            <a:xfrm>
              <a:off x="1134720" y="4422960"/>
              <a:ext cx="3429000" cy="5000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prstDash val="lg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01" name="직사각형 21"/>
            <p:cNvSpPr/>
            <p:nvPr/>
          </p:nvSpPr>
          <p:spPr>
            <a:xfrm>
              <a:off x="5526000" y="4518360"/>
              <a:ext cx="3430800" cy="4460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prstDash val="lg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02" name="TextBox 45"/>
            <p:cNvSpPr/>
            <p:nvPr/>
          </p:nvSpPr>
          <p:spPr>
            <a:xfrm>
              <a:off x="4770000" y="4581360"/>
              <a:ext cx="721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3 kDa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pSp>
        <p:nvGrpSpPr>
          <p:cNvPr id="503" name="그룹 58"/>
          <p:cNvGrpSpPr/>
          <p:nvPr/>
        </p:nvGrpSpPr>
        <p:grpSpPr>
          <a:xfrm>
            <a:off x="-70200" y="971640"/>
            <a:ext cx="616680" cy="4327560"/>
            <a:chOff x="-70200" y="971640"/>
            <a:chExt cx="616680" cy="4327560"/>
          </a:xfrm>
        </p:grpSpPr>
        <p:grpSp>
          <p:nvGrpSpPr>
            <p:cNvPr id="504" name="그룹 44"/>
            <p:cNvGrpSpPr/>
            <p:nvPr/>
          </p:nvGrpSpPr>
          <p:grpSpPr>
            <a:xfrm>
              <a:off x="33480" y="1326960"/>
              <a:ext cx="390960" cy="3972240"/>
              <a:chOff x="33480" y="1326960"/>
              <a:chExt cx="390960" cy="3972240"/>
            </a:xfrm>
          </p:grpSpPr>
          <p:sp>
            <p:nvSpPr>
              <p:cNvPr id="505" name="직사각형 45"/>
              <p:cNvSpPr/>
              <p:nvPr/>
            </p:nvSpPr>
            <p:spPr>
              <a:xfrm>
                <a:off x="74520" y="1326960"/>
                <a:ext cx="287640" cy="3907440"/>
              </a:xfrm>
              <a:prstGeom prst="rect">
                <a:avLst/>
              </a:prstGeom>
              <a:noFill/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06" name="직선 연결선 46"/>
              <p:cNvSpPr/>
              <p:nvPr/>
            </p:nvSpPr>
            <p:spPr>
              <a:xfrm>
                <a:off x="74520" y="4646880"/>
                <a:ext cx="287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07" name="직선 연결선 47"/>
              <p:cNvSpPr/>
              <p:nvPr/>
            </p:nvSpPr>
            <p:spPr>
              <a:xfrm>
                <a:off x="74520" y="3875040"/>
                <a:ext cx="287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08" name="직선 연결선 48"/>
              <p:cNvSpPr/>
              <p:nvPr/>
            </p:nvSpPr>
            <p:spPr>
              <a:xfrm>
                <a:off x="74520" y="3411360"/>
                <a:ext cx="287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09" name="직선 연결선 49"/>
              <p:cNvSpPr/>
              <p:nvPr/>
            </p:nvSpPr>
            <p:spPr>
              <a:xfrm>
                <a:off x="66600" y="2660400"/>
                <a:ext cx="287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0" name="TextBox 50"/>
              <p:cNvSpPr/>
              <p:nvPr/>
            </p:nvSpPr>
            <p:spPr>
              <a:xfrm>
                <a:off x="57240" y="4434840"/>
                <a:ext cx="320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13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1" name="TextBox 51"/>
              <p:cNvSpPr/>
              <p:nvPr/>
            </p:nvSpPr>
            <p:spPr>
              <a:xfrm>
                <a:off x="68760" y="3661560"/>
                <a:ext cx="320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25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2" name="TextBox 52"/>
              <p:cNvSpPr/>
              <p:nvPr/>
            </p:nvSpPr>
            <p:spPr>
              <a:xfrm>
                <a:off x="68760" y="3178080"/>
                <a:ext cx="320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43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3" name="TextBox 53"/>
              <p:cNvSpPr/>
              <p:nvPr/>
            </p:nvSpPr>
            <p:spPr>
              <a:xfrm>
                <a:off x="75960" y="2429640"/>
                <a:ext cx="320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85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4" name="TextBox 54"/>
              <p:cNvSpPr/>
              <p:nvPr/>
            </p:nvSpPr>
            <p:spPr>
              <a:xfrm>
                <a:off x="108720" y="5037840"/>
                <a:ext cx="250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3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5" name="TextBox 55"/>
              <p:cNvSpPr/>
              <p:nvPr/>
            </p:nvSpPr>
            <p:spPr>
              <a:xfrm>
                <a:off x="57240" y="2049840"/>
                <a:ext cx="320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98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16" name="TextBox 56"/>
              <p:cNvSpPr/>
              <p:nvPr/>
            </p:nvSpPr>
            <p:spPr>
              <a:xfrm>
                <a:off x="33480" y="1670400"/>
                <a:ext cx="3909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198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517" name="TextBox 57"/>
            <p:cNvSpPr/>
            <p:nvPr/>
          </p:nvSpPr>
          <p:spPr>
            <a:xfrm>
              <a:off x="-70200" y="971640"/>
              <a:ext cx="616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(kDa)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518" name="TextBox 29"/>
          <p:cNvSpPr/>
          <p:nvPr/>
        </p:nvSpPr>
        <p:spPr>
          <a:xfrm>
            <a:off x="-20520" y="50760"/>
            <a:ext cx="7211880" cy="35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700" spc="-1" strike="noStrike">
                <a:solidFill>
                  <a:srgbClr val="000000"/>
                </a:solidFill>
                <a:latin typeface="Times New Roman"/>
                <a:ea typeface="굴림"/>
              </a:rPr>
              <a:t>Supplementary Figure 1. </a:t>
            </a:r>
            <a:r>
              <a:rPr b="0" lang="en-US" sz="1700" spc="-1" strike="noStrike">
                <a:solidFill>
                  <a:srgbClr val="000000"/>
                </a:solidFill>
                <a:latin typeface="Times New Roman"/>
                <a:ea typeface="굴림"/>
              </a:rPr>
              <a:t>Original, unprocessed version of Western blots.</a:t>
            </a:r>
            <a:endParaRPr b="0" lang="en-US" sz="17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9" name="그룹 16"/>
          <p:cNvGrpSpPr/>
          <p:nvPr/>
        </p:nvGrpSpPr>
        <p:grpSpPr>
          <a:xfrm>
            <a:off x="336240" y="852480"/>
            <a:ext cx="8901360" cy="4627440"/>
            <a:chOff x="336240" y="852480"/>
            <a:chExt cx="8901360" cy="4627440"/>
          </a:xfrm>
        </p:grpSpPr>
        <p:pic>
          <p:nvPicPr>
            <p:cNvPr id="520" name="그림 1" descr=""/>
            <p:cNvPicPr/>
            <p:nvPr/>
          </p:nvPicPr>
          <p:blipFill>
            <a:blip r:embed="rId1"/>
            <a:stretch/>
          </p:blipFill>
          <p:spPr>
            <a:xfrm>
              <a:off x="1088280" y="1562400"/>
              <a:ext cx="3460320" cy="390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1" name="그림 2" descr=""/>
            <p:cNvPicPr/>
            <p:nvPr/>
          </p:nvPicPr>
          <p:blipFill>
            <a:blip r:embed="rId2"/>
            <a:stretch/>
          </p:blipFill>
          <p:spPr>
            <a:xfrm>
              <a:off x="5480640" y="1575360"/>
              <a:ext cx="3447000" cy="3904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2" name="TextBox 10"/>
            <p:cNvSpPr/>
            <p:nvPr/>
          </p:nvSpPr>
          <p:spPr>
            <a:xfrm>
              <a:off x="997920" y="1215360"/>
              <a:ext cx="3888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DM-Hi  DM-Lo  DM-No Sham-Hi  Sham-Lo Sham-No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23" name="TextBox 10"/>
            <p:cNvSpPr/>
            <p:nvPr/>
          </p:nvSpPr>
          <p:spPr>
            <a:xfrm>
              <a:off x="5349240" y="1215360"/>
              <a:ext cx="3888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DM-Hi  DM-Lo  DM-No Sham-Hi  Sham-Lo Sham-No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24" name="직사각형 10"/>
            <p:cNvSpPr/>
            <p:nvPr/>
          </p:nvSpPr>
          <p:spPr>
            <a:xfrm>
              <a:off x="1103760" y="2655720"/>
              <a:ext cx="3430440" cy="5029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prstDash val="lg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25" name="직사각형 11"/>
            <p:cNvSpPr/>
            <p:nvPr/>
          </p:nvSpPr>
          <p:spPr>
            <a:xfrm>
              <a:off x="5483160" y="3806640"/>
              <a:ext cx="3430440" cy="5047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prstDash val="lg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26" name="TextBox 44"/>
            <p:cNvSpPr/>
            <p:nvPr/>
          </p:nvSpPr>
          <p:spPr>
            <a:xfrm>
              <a:off x="336240" y="2753280"/>
              <a:ext cx="721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85 kDa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27" name="TextBox 44"/>
            <p:cNvSpPr/>
            <p:nvPr/>
          </p:nvSpPr>
          <p:spPr>
            <a:xfrm>
              <a:off x="4741560" y="3905280"/>
              <a:ext cx="721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25 kDa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28" name="TextBox 8"/>
            <p:cNvSpPr/>
            <p:nvPr/>
          </p:nvSpPr>
          <p:spPr>
            <a:xfrm>
              <a:off x="1043280" y="852480"/>
              <a:ext cx="3843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Western blot (Front paw) – PI3-K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29" name="TextBox 8"/>
            <p:cNvSpPr/>
            <p:nvPr/>
          </p:nvSpPr>
          <p:spPr>
            <a:xfrm>
              <a:off x="5436000" y="852480"/>
              <a:ext cx="3477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Western blot (Front paw) - IENF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pSp>
        <p:nvGrpSpPr>
          <p:cNvPr id="530" name="그룹 33"/>
          <p:cNvGrpSpPr/>
          <p:nvPr/>
        </p:nvGrpSpPr>
        <p:grpSpPr>
          <a:xfrm>
            <a:off x="-83160" y="1184400"/>
            <a:ext cx="616680" cy="4363920"/>
            <a:chOff x="-83160" y="1184400"/>
            <a:chExt cx="616680" cy="4363920"/>
          </a:xfrm>
        </p:grpSpPr>
        <p:grpSp>
          <p:nvGrpSpPr>
            <p:cNvPr id="531" name="그룹 31"/>
            <p:cNvGrpSpPr/>
            <p:nvPr/>
          </p:nvGrpSpPr>
          <p:grpSpPr>
            <a:xfrm>
              <a:off x="-720" y="1575000"/>
              <a:ext cx="390960" cy="3973320"/>
              <a:chOff x="-720" y="1575000"/>
              <a:chExt cx="390960" cy="3973320"/>
            </a:xfrm>
          </p:grpSpPr>
          <p:sp>
            <p:nvSpPr>
              <p:cNvPr id="532" name="직사각형 26"/>
              <p:cNvSpPr/>
              <p:nvPr/>
            </p:nvSpPr>
            <p:spPr>
              <a:xfrm>
                <a:off x="39600" y="1575000"/>
                <a:ext cx="288720" cy="3908520"/>
              </a:xfrm>
              <a:prstGeom prst="rect">
                <a:avLst/>
              </a:prstGeom>
              <a:noFill/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3" name="직선 연결선 27"/>
              <p:cNvSpPr/>
              <p:nvPr/>
            </p:nvSpPr>
            <p:spPr>
              <a:xfrm>
                <a:off x="39600" y="4896000"/>
                <a:ext cx="2887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4" name="직선 연결선 28"/>
              <p:cNvSpPr/>
              <p:nvPr/>
            </p:nvSpPr>
            <p:spPr>
              <a:xfrm>
                <a:off x="39600" y="4122720"/>
                <a:ext cx="2887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5" name="직선 연결선 29"/>
              <p:cNvSpPr/>
              <p:nvPr/>
            </p:nvSpPr>
            <p:spPr>
              <a:xfrm>
                <a:off x="39600" y="3659400"/>
                <a:ext cx="2887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6" name="직선 연결선 30"/>
              <p:cNvSpPr/>
              <p:nvPr/>
            </p:nvSpPr>
            <p:spPr>
              <a:xfrm>
                <a:off x="31680" y="2908440"/>
                <a:ext cx="2887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7" name="TextBox 19"/>
              <p:cNvSpPr/>
              <p:nvPr/>
            </p:nvSpPr>
            <p:spPr>
              <a:xfrm>
                <a:off x="23040" y="4683960"/>
                <a:ext cx="320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13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8" name="TextBox 20"/>
              <p:cNvSpPr/>
              <p:nvPr/>
            </p:nvSpPr>
            <p:spPr>
              <a:xfrm>
                <a:off x="34200" y="3910320"/>
                <a:ext cx="320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25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39" name="TextBox 21"/>
              <p:cNvSpPr/>
              <p:nvPr/>
            </p:nvSpPr>
            <p:spPr>
              <a:xfrm>
                <a:off x="34200" y="3426840"/>
                <a:ext cx="320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43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40" name="TextBox 22"/>
              <p:cNvSpPr/>
              <p:nvPr/>
            </p:nvSpPr>
            <p:spPr>
              <a:xfrm>
                <a:off x="41760" y="2678040"/>
                <a:ext cx="320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85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41" name="TextBox 23"/>
              <p:cNvSpPr/>
              <p:nvPr/>
            </p:nvSpPr>
            <p:spPr>
              <a:xfrm>
                <a:off x="74160" y="5286960"/>
                <a:ext cx="250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3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42" name="TextBox 24"/>
              <p:cNvSpPr/>
              <p:nvPr/>
            </p:nvSpPr>
            <p:spPr>
              <a:xfrm>
                <a:off x="23040" y="2298600"/>
                <a:ext cx="320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98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43" name="TextBox 25"/>
              <p:cNvSpPr/>
              <p:nvPr/>
            </p:nvSpPr>
            <p:spPr>
              <a:xfrm>
                <a:off x="-720" y="1918800"/>
                <a:ext cx="3909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198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544" name="TextBox 32"/>
            <p:cNvSpPr/>
            <p:nvPr/>
          </p:nvSpPr>
          <p:spPr>
            <a:xfrm>
              <a:off x="-83160" y="1184400"/>
              <a:ext cx="616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(kDa)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5" name="그룹 18"/>
          <p:cNvGrpSpPr/>
          <p:nvPr/>
        </p:nvGrpSpPr>
        <p:grpSpPr>
          <a:xfrm>
            <a:off x="258120" y="981000"/>
            <a:ext cx="9061920" cy="4603680"/>
            <a:chOff x="258120" y="981000"/>
            <a:chExt cx="9061920" cy="4603680"/>
          </a:xfrm>
        </p:grpSpPr>
        <p:pic>
          <p:nvPicPr>
            <p:cNvPr id="546" name="그림 1" descr=""/>
            <p:cNvPicPr/>
            <p:nvPr/>
          </p:nvPicPr>
          <p:blipFill>
            <a:blip r:embed="rId1"/>
            <a:stretch/>
          </p:blipFill>
          <p:spPr>
            <a:xfrm>
              <a:off x="1075680" y="1677600"/>
              <a:ext cx="3460320" cy="3907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7" name="그림 2" descr=""/>
            <p:cNvPicPr/>
            <p:nvPr/>
          </p:nvPicPr>
          <p:blipFill>
            <a:blip r:embed="rId2"/>
            <a:stretch/>
          </p:blipFill>
          <p:spPr>
            <a:xfrm>
              <a:off x="5575680" y="1657800"/>
              <a:ext cx="3446280" cy="3907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8" name="TextBox 10"/>
            <p:cNvSpPr/>
            <p:nvPr/>
          </p:nvSpPr>
          <p:spPr>
            <a:xfrm>
              <a:off x="896760" y="1335600"/>
              <a:ext cx="388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DM-Hi  DM-Lo  DM-No Sham-Hi  Sham-Lo Sham-No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49" name="TextBox 10"/>
            <p:cNvSpPr/>
            <p:nvPr/>
          </p:nvSpPr>
          <p:spPr>
            <a:xfrm>
              <a:off x="5431320" y="1335600"/>
              <a:ext cx="388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DM-Hi  DM-Lo  DM-No Sham-Hi  Sham-Lo Sham-No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50" name="TextBox 8"/>
            <p:cNvSpPr/>
            <p:nvPr/>
          </p:nvSpPr>
          <p:spPr>
            <a:xfrm>
              <a:off x="1043640" y="982800"/>
              <a:ext cx="3888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Western blot (Front paw) – TNF-α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51" name="TextBox 8"/>
            <p:cNvSpPr/>
            <p:nvPr/>
          </p:nvSpPr>
          <p:spPr>
            <a:xfrm>
              <a:off x="5436000" y="981000"/>
              <a:ext cx="3560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Western blot (Front paw) – B-actin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52" name="직사각형 10"/>
            <p:cNvSpPr/>
            <p:nvPr/>
          </p:nvSpPr>
          <p:spPr>
            <a:xfrm>
              <a:off x="1090440" y="3890880"/>
              <a:ext cx="3430440" cy="639720"/>
            </a:xfrm>
            <a:prstGeom prst="rect">
              <a:avLst/>
            </a:prstGeom>
            <a:noFill/>
            <a:ln w="19080">
              <a:solidFill>
                <a:srgbClr val="7f7f7f"/>
              </a:solidFill>
              <a:prstDash val="lg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53" name="직사각형 11"/>
            <p:cNvSpPr/>
            <p:nvPr/>
          </p:nvSpPr>
          <p:spPr>
            <a:xfrm>
              <a:off x="5582880" y="3582720"/>
              <a:ext cx="3430440" cy="51588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prstDash val="lg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54" name="TextBox 44"/>
            <p:cNvSpPr/>
            <p:nvPr/>
          </p:nvSpPr>
          <p:spPr>
            <a:xfrm>
              <a:off x="4810320" y="3583800"/>
              <a:ext cx="721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43 kDa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55" name="TextBox 44"/>
            <p:cNvSpPr/>
            <p:nvPr/>
          </p:nvSpPr>
          <p:spPr>
            <a:xfrm>
              <a:off x="258120" y="3777480"/>
              <a:ext cx="849600" cy="45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26 kDa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(membrane)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56" name="TextBox 44"/>
            <p:cNvSpPr/>
            <p:nvPr/>
          </p:nvSpPr>
          <p:spPr>
            <a:xfrm>
              <a:off x="302040" y="4210920"/>
              <a:ext cx="721800" cy="45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17 kDa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(soluble)</a:t>
              </a:r>
              <a:endParaRPr b="0" lang="en-US" sz="10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pSp>
        <p:nvGrpSpPr>
          <p:cNvPr id="557" name="그룹 47"/>
          <p:cNvGrpSpPr/>
          <p:nvPr/>
        </p:nvGrpSpPr>
        <p:grpSpPr>
          <a:xfrm>
            <a:off x="-79920" y="1225440"/>
            <a:ext cx="616680" cy="4372200"/>
            <a:chOff x="-79920" y="1225440"/>
            <a:chExt cx="616680" cy="4372200"/>
          </a:xfrm>
        </p:grpSpPr>
        <p:grpSp>
          <p:nvGrpSpPr>
            <p:cNvPr id="558" name="그룹 33"/>
            <p:cNvGrpSpPr/>
            <p:nvPr/>
          </p:nvGrpSpPr>
          <p:grpSpPr>
            <a:xfrm>
              <a:off x="-2880" y="1624320"/>
              <a:ext cx="390960" cy="3973320"/>
              <a:chOff x="-2880" y="1624320"/>
              <a:chExt cx="390960" cy="3973320"/>
            </a:xfrm>
          </p:grpSpPr>
          <p:sp>
            <p:nvSpPr>
              <p:cNvPr id="559" name="직사각형 34"/>
              <p:cNvSpPr/>
              <p:nvPr/>
            </p:nvSpPr>
            <p:spPr>
              <a:xfrm>
                <a:off x="38160" y="1624320"/>
                <a:ext cx="287640" cy="3908520"/>
              </a:xfrm>
              <a:prstGeom prst="rect">
                <a:avLst/>
              </a:prstGeom>
              <a:noFill/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60" name="직선 연결선 35"/>
              <p:cNvSpPr/>
              <p:nvPr/>
            </p:nvSpPr>
            <p:spPr>
              <a:xfrm>
                <a:off x="38160" y="4945320"/>
                <a:ext cx="287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61" name="직선 연결선 36"/>
              <p:cNvSpPr/>
              <p:nvPr/>
            </p:nvSpPr>
            <p:spPr>
              <a:xfrm>
                <a:off x="38160" y="4172040"/>
                <a:ext cx="287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62" name="직선 연결선 37"/>
              <p:cNvSpPr/>
              <p:nvPr/>
            </p:nvSpPr>
            <p:spPr>
              <a:xfrm>
                <a:off x="38160" y="3708720"/>
                <a:ext cx="287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63" name="직선 연결선 38"/>
              <p:cNvSpPr/>
              <p:nvPr/>
            </p:nvSpPr>
            <p:spPr>
              <a:xfrm>
                <a:off x="30240" y="2957760"/>
                <a:ext cx="287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64" name="TextBox 39"/>
              <p:cNvSpPr/>
              <p:nvPr/>
            </p:nvSpPr>
            <p:spPr>
              <a:xfrm>
                <a:off x="20880" y="4733280"/>
                <a:ext cx="320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13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65" name="TextBox 40"/>
              <p:cNvSpPr/>
              <p:nvPr/>
            </p:nvSpPr>
            <p:spPr>
              <a:xfrm>
                <a:off x="32400" y="3959640"/>
                <a:ext cx="320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25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66" name="TextBox 41"/>
              <p:cNvSpPr/>
              <p:nvPr/>
            </p:nvSpPr>
            <p:spPr>
              <a:xfrm>
                <a:off x="32400" y="3476160"/>
                <a:ext cx="320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43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67" name="TextBox 42"/>
              <p:cNvSpPr/>
              <p:nvPr/>
            </p:nvSpPr>
            <p:spPr>
              <a:xfrm>
                <a:off x="39600" y="2727720"/>
                <a:ext cx="320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85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68" name="TextBox 43"/>
              <p:cNvSpPr/>
              <p:nvPr/>
            </p:nvSpPr>
            <p:spPr>
              <a:xfrm>
                <a:off x="72360" y="5336280"/>
                <a:ext cx="2509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3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69" name="TextBox 44"/>
              <p:cNvSpPr/>
              <p:nvPr/>
            </p:nvSpPr>
            <p:spPr>
              <a:xfrm>
                <a:off x="20880" y="2347920"/>
                <a:ext cx="3207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98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70" name="TextBox 45"/>
              <p:cNvSpPr/>
              <p:nvPr/>
            </p:nvSpPr>
            <p:spPr>
              <a:xfrm>
                <a:off x="-2880" y="1968120"/>
                <a:ext cx="3909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  <a:ea typeface="굴림"/>
                  </a:rPr>
                  <a:t>198</a:t>
                </a:r>
                <a:endParaRPr b="0" lang="en-US" sz="11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sp>
          <p:nvSpPr>
            <p:cNvPr id="571" name="TextBox 46"/>
            <p:cNvSpPr/>
            <p:nvPr/>
          </p:nvSpPr>
          <p:spPr>
            <a:xfrm>
              <a:off x="-79920" y="1225440"/>
              <a:ext cx="616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굴림"/>
                </a:rPr>
                <a:t>(kDa)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1-24T18:25:52Z</dcterms:created>
  <dc:creator>Registered User</dc:creator>
  <dc:description/>
  <dc:language>en-US</dc:language>
  <cp:lastModifiedBy>DM500T8Z-AD3A</cp:lastModifiedBy>
  <dcterms:modified xsi:type="dcterms:W3CDTF">2020-03-30T00:05:31Z</dcterms:modified>
  <cp:revision>347</cp:revision>
  <dc:subject/>
  <dc:title>슬라이드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">
    <vt:lpwstr>NSCCustomProperty</vt:lpwstr>
  </property>
  <property fmtid="{D5CDD505-2E9C-101B-9397-08002B2CF9AE}" pid="3" name="NSCPROP_SA">
    <vt:lpwstr>C:\Users\DM500T8Z-AD3A\Desktop\DOE 파일\동물 실험\Scientific reports 2020\Revision\supplementary figure ppt BY NSU (200305).ppt</vt:lpwstr>
  </property>
</Properties>
</file>